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04" d="100"/>
          <a:sy n="104" d="100"/>
        </p:scale>
        <p:origin x="-3328" y="-12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ACB6C-8F02-894A-8624-A1DA942E856F}" type="datetimeFigureOut">
              <a:rPr lang="en-US" smtClean="0"/>
              <a:t>09/11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5D030-6AE6-1149-9691-ECE897C255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55593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ACB6C-8F02-894A-8624-A1DA942E856F}" type="datetimeFigureOut">
              <a:rPr lang="en-US" smtClean="0"/>
              <a:t>09/11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5D030-6AE6-1149-9691-ECE897C255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73772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ACB6C-8F02-894A-8624-A1DA942E856F}" type="datetimeFigureOut">
              <a:rPr lang="en-US" smtClean="0"/>
              <a:t>09/11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5D030-6AE6-1149-9691-ECE897C255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15207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ACB6C-8F02-894A-8624-A1DA942E856F}" type="datetimeFigureOut">
              <a:rPr lang="en-US" smtClean="0"/>
              <a:t>09/11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5D030-6AE6-1149-9691-ECE897C255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39634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ACB6C-8F02-894A-8624-A1DA942E856F}" type="datetimeFigureOut">
              <a:rPr lang="en-US" smtClean="0"/>
              <a:t>09/11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5D030-6AE6-1149-9691-ECE897C255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8389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ACB6C-8F02-894A-8624-A1DA942E856F}" type="datetimeFigureOut">
              <a:rPr lang="en-US" smtClean="0"/>
              <a:t>09/11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5D030-6AE6-1149-9691-ECE897C255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59606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ACB6C-8F02-894A-8624-A1DA942E856F}" type="datetimeFigureOut">
              <a:rPr lang="en-US" smtClean="0"/>
              <a:t>09/11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5D030-6AE6-1149-9691-ECE897C255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21289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ACB6C-8F02-894A-8624-A1DA942E856F}" type="datetimeFigureOut">
              <a:rPr lang="en-US" smtClean="0"/>
              <a:t>09/11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5D030-6AE6-1149-9691-ECE897C255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77879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ACB6C-8F02-894A-8624-A1DA942E856F}" type="datetimeFigureOut">
              <a:rPr lang="en-US" smtClean="0"/>
              <a:t>09/11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5D030-6AE6-1149-9691-ECE897C255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31533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ACB6C-8F02-894A-8624-A1DA942E856F}" type="datetimeFigureOut">
              <a:rPr lang="en-US" smtClean="0"/>
              <a:t>09/11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5D030-6AE6-1149-9691-ECE897C255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90653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ACB6C-8F02-894A-8624-A1DA942E856F}" type="datetimeFigureOut">
              <a:rPr lang="en-US" smtClean="0"/>
              <a:t>09/11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5D030-6AE6-1149-9691-ECE897C255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64901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DACB6C-8F02-894A-8624-A1DA942E856F}" type="datetimeFigureOut">
              <a:rPr lang="en-US" smtClean="0"/>
              <a:t>09/11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55D030-6AE6-1149-9691-ECE897C255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72366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4105" y="2088313"/>
            <a:ext cx="5528057" cy="287342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98338" y="6533609"/>
            <a:ext cx="5641479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 smtClean="0"/>
              <a:t>Supplementary Figure 1. </a:t>
            </a:r>
            <a:r>
              <a:rPr lang="en-US" dirty="0" smtClean="0"/>
              <a:t>The susceptibility of 293 cells transiently transfected with </a:t>
            </a:r>
            <a:r>
              <a:rPr lang="en-US" dirty="0" err="1" smtClean="0"/>
              <a:t>pDisplay</a:t>
            </a:r>
            <a:r>
              <a:rPr lang="en-US" dirty="0" smtClean="0"/>
              <a:t> and </a:t>
            </a:r>
            <a:r>
              <a:rPr lang="en-US" dirty="0" err="1" smtClean="0"/>
              <a:t>pDisplay</a:t>
            </a:r>
            <a:r>
              <a:rPr lang="en-US" dirty="0" smtClean="0"/>
              <a:t>-dogSLAM, or stably transfected with </a:t>
            </a:r>
            <a:r>
              <a:rPr lang="en-US" dirty="0" err="1" smtClean="0"/>
              <a:t>pDisplay</a:t>
            </a:r>
            <a:r>
              <a:rPr lang="en-US" dirty="0" smtClean="0"/>
              <a:t>-dogSLAM to infection with VSV(CDV) pseudotypes was compared. Infection of the 293 cells with Onderstepoort (ONDS), A94/11/14 and A94/11/15 strains was confirmed to be SLAM-dependent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608557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67</Words>
  <Application>Microsoft Macintosh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Glasgow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ian Willett</dc:creator>
  <cp:lastModifiedBy>Brian Willett</cp:lastModifiedBy>
  <cp:revision>1</cp:revision>
  <dcterms:created xsi:type="dcterms:W3CDTF">2015-11-09T10:40:41Z</dcterms:created>
  <dcterms:modified xsi:type="dcterms:W3CDTF">2015-11-09T10:46:30Z</dcterms:modified>
</cp:coreProperties>
</file>